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06" autoAdjust="0"/>
    <p:restoredTop sz="94660"/>
  </p:normalViewPr>
  <p:slideViewPr>
    <p:cSldViewPr snapToGrid="0">
      <p:cViewPr varScale="1">
        <p:scale>
          <a:sx n="83" d="100"/>
          <a:sy n="83" d="100"/>
        </p:scale>
        <p:origin x="210" y="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B21E39-501E-6C49-7A83-7993E8847C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7A0D78F-0BC8-2CAF-0F64-11C7AC6580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DC3FD24-5E69-0270-67E2-D3C1FA9F6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0583-D308-4B1C-AA80-7BCAD6C1C8F8}" type="datetimeFigureOut">
              <a:rPr lang="zh-CN" altLang="en-US" smtClean="0"/>
              <a:t>2025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BCAB14F-4DA1-A84D-3D04-11520CB848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F6E12B-A9FE-1A2F-F1FA-FCBE54D8C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64EA0-38F1-4838-95C2-A0C2594688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6847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9677A92-BAA5-DAA8-92F3-D5EAD7E373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94D3192-6838-8712-39EC-FC387419BF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D48EA27-5C2A-8022-C2A7-08012DEFAC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0583-D308-4B1C-AA80-7BCAD6C1C8F8}" type="datetimeFigureOut">
              <a:rPr lang="zh-CN" altLang="en-US" smtClean="0"/>
              <a:t>2025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78A5ECC-9D44-4E53-551B-EEC3422C36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FC273FB-2AB7-7490-0607-DBF77C3E7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64EA0-38F1-4838-95C2-A0C2594688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3925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484E993-7A20-6C1F-3BE9-D319FD566EB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C7C9890-B7E2-7986-A77D-013ABE9250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949255-5F1A-4728-0CBD-21FC667239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0583-D308-4B1C-AA80-7BCAD6C1C8F8}" type="datetimeFigureOut">
              <a:rPr lang="zh-CN" altLang="en-US" smtClean="0"/>
              <a:t>2025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235BF5B-C8A6-3FFE-D00A-8F14066F83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B96B1D1-F47C-FC29-42EF-C318FBE7C0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64EA0-38F1-4838-95C2-A0C2594688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81594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14AAB8-9450-4430-335A-5A2E2F1B79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5BFD921-2BFA-9273-564B-07ADB6AA7E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C63F3F3-720C-C0CE-C0BA-75E949A61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0583-D308-4B1C-AA80-7BCAD6C1C8F8}" type="datetimeFigureOut">
              <a:rPr lang="zh-CN" altLang="en-US" smtClean="0"/>
              <a:t>2025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5F888AA-2A07-D2EC-9973-1BBA5FF71A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D0F102-4F37-7B15-75A1-C1699B8AE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64EA0-38F1-4838-95C2-A0C2594688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71301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2320A55-5758-CAFD-68F9-A4EEDAF8C4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D134044-6DDA-38CE-7DF0-AE446E0FE5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58A8A65-DAC9-570A-9454-AD7AE0E755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0583-D308-4B1C-AA80-7BCAD6C1C8F8}" type="datetimeFigureOut">
              <a:rPr lang="zh-CN" altLang="en-US" smtClean="0"/>
              <a:t>2025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407BC79-05BB-828B-C6D5-6AAC30D851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786F2BA-D416-A795-4CB6-7E4C30ECC7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64EA0-38F1-4838-95C2-A0C2594688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4483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1DFB926-3E76-F348-EFDD-2AE80B8CEF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EA98033-3AD8-30EC-62EB-78CD5E2956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D68C0BA-3F93-EC8B-FCF1-167B8DDA69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4425137-18DF-CC95-6C14-19ABFE62AA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0583-D308-4B1C-AA80-7BCAD6C1C8F8}" type="datetimeFigureOut">
              <a:rPr lang="zh-CN" altLang="en-US" smtClean="0"/>
              <a:t>2025/1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A4758D8-61D7-6A83-4170-ED083DED0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DDAEA62-D2DC-55FC-C037-3DF147A28A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64EA0-38F1-4838-95C2-A0C2594688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5763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91CEE27-DA1A-09D2-893D-4F667A36CC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B9683B6-23A3-CC2B-474F-8101CF0462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E673DF0-239D-329F-DB71-F6E0F9C476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8E79141-C88D-DABB-9FDA-01F19E06533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06056EA-BC6E-1168-94D4-75804519F41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9F091F0C-A375-B556-CB06-2BF77A8A45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0583-D308-4B1C-AA80-7BCAD6C1C8F8}" type="datetimeFigureOut">
              <a:rPr lang="zh-CN" altLang="en-US" smtClean="0"/>
              <a:t>2025/12/1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5BC4D1C-7CA4-89D0-57EC-9FA474A00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CBE9665-BF3B-2150-1A4C-363B59CF61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64EA0-38F1-4838-95C2-A0C2594688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8396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504B4CC-A45D-11AE-FE56-6012B57953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9F59CD7-B5B2-D5FE-E300-0484FC4DDD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0583-D308-4B1C-AA80-7BCAD6C1C8F8}" type="datetimeFigureOut">
              <a:rPr lang="zh-CN" altLang="en-US" smtClean="0"/>
              <a:t>2025/12/1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6105E5A-7EEF-8FD8-CFF3-15DCC44DE5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E5E281E-2709-D72D-7563-EF1AE0091A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64EA0-38F1-4838-95C2-A0C2594688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92192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2069780A-C925-0513-FEEB-19063C83F7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0583-D308-4B1C-AA80-7BCAD6C1C8F8}" type="datetimeFigureOut">
              <a:rPr lang="zh-CN" altLang="en-US" smtClean="0"/>
              <a:t>2025/12/1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28F56B8-A5D5-7581-E413-442F0A8B05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70FE9DA-2870-CA80-7707-CAA44FEB74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64EA0-38F1-4838-95C2-A0C2594688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55968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4AF6E4-FF10-01D4-B597-C8B65771FE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75DE0EA-55C1-8A69-2CCE-B948BD06EC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73F738B-DA86-C86D-3E67-2474285C8F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2E16FF0-227B-3215-B4EB-77BC02ACAF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0583-D308-4B1C-AA80-7BCAD6C1C8F8}" type="datetimeFigureOut">
              <a:rPr lang="zh-CN" altLang="en-US" smtClean="0"/>
              <a:t>2025/1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A8B6EEB-3A45-BBD7-FF9C-12249AADC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22C7520-13CA-A1AA-E979-112151269D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64EA0-38F1-4838-95C2-A0C2594688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2506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01B24CD-0616-8DEA-C5AC-1F63DA2129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7CAA72D-D7A1-875D-5DE6-95C80E1525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03B9CFD-8F89-414D-6806-E573CEE803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74CD2C0-FEB8-BDC2-F2FB-E5CD24A6F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10583-D308-4B1C-AA80-7BCAD6C1C8F8}" type="datetimeFigureOut">
              <a:rPr lang="zh-CN" altLang="en-US" smtClean="0"/>
              <a:t>2025/12/1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12C9FF3-8120-47BE-521E-4017A82E43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20E2FB-1DE6-A5FA-6C19-AF822D49E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64EA0-38F1-4838-95C2-A0C2594688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8390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B85ADF0A-7749-C685-1FE1-013498B025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E2A653E-788A-C487-0D93-10DB90DF06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877B0FE-B92D-26BA-C7AC-57B9B69AFDA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E10583-D308-4B1C-AA80-7BCAD6C1C8F8}" type="datetimeFigureOut">
              <a:rPr lang="zh-CN" altLang="en-US" smtClean="0"/>
              <a:t>2025/12/1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C5B6DCE-FD7B-8112-23A1-9D8C2CA21A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69C841-5AE5-FE6C-75AF-4433CFAA4AC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664EA0-38F1-4838-95C2-A0C25946883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6314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6E2A0D7-9839-4A17-C9F2-0FC0533C04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318" y="66271"/>
            <a:ext cx="8597660" cy="303940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74C43CA-9A38-7B4B-D7AD-11164318B23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5955" y="3105678"/>
            <a:ext cx="8442385" cy="2984515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38D7E872-DA79-7088-EB7D-DF4EAB3D0DF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9820" y="49017"/>
            <a:ext cx="8655912" cy="306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8FB4DF8-A08C-E126-3468-89FE333487A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456" y="3088424"/>
            <a:ext cx="8655912" cy="306000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B296806-51E0-4219-535D-1B1B7963FB7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982" y="38195"/>
            <a:ext cx="8640000" cy="3054375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03C982DF-131C-FA76-86DE-67AB9D2C7DC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7776" y="3082800"/>
            <a:ext cx="8640000" cy="3054375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8E28EDE7-952F-585B-D7BE-8A9072C0C9B6}"/>
              </a:ext>
            </a:extLst>
          </p:cNvPr>
          <p:cNvSpPr txBox="1"/>
          <p:nvPr/>
        </p:nvSpPr>
        <p:spPr>
          <a:xfrm>
            <a:off x="250166" y="6270767"/>
            <a:ext cx="897434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Supplementary figure.1 Calibration curve (left) and decision curve analysis (DCA, right).</a:t>
            </a:r>
          </a:p>
          <a:p>
            <a:r>
              <a:rPr lang="en-US" altLang="zh-CN" dirty="0"/>
              <a:t> (A) Training set ;(B)Validation set.  </a:t>
            </a:r>
            <a:endParaRPr lang="zh-CN" altLang="en-US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C8C4C1F5-F43D-47F1-059C-46DAAA7B916A}"/>
              </a:ext>
            </a:extLst>
          </p:cNvPr>
          <p:cNvSpPr txBox="1"/>
          <p:nvPr/>
        </p:nvSpPr>
        <p:spPr>
          <a:xfrm>
            <a:off x="130935" y="217901"/>
            <a:ext cx="4428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/>
              <a:t>A</a:t>
            </a:r>
            <a:endParaRPr lang="zh-CN" altLang="en-US" b="1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1A9DE535-4267-7557-7FC8-22EF44ADABB6}"/>
              </a:ext>
            </a:extLst>
          </p:cNvPr>
          <p:cNvSpPr txBox="1"/>
          <p:nvPr/>
        </p:nvSpPr>
        <p:spPr>
          <a:xfrm>
            <a:off x="104386" y="3058696"/>
            <a:ext cx="50608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/>
              <a:t>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1719339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3AD2B3B9-1C9F-D890-F5F1-0921BC8C300A}"/>
              </a:ext>
            </a:extLst>
          </p:cNvPr>
          <p:cNvSpPr txBox="1"/>
          <p:nvPr/>
        </p:nvSpPr>
        <p:spPr>
          <a:xfrm>
            <a:off x="534838" y="5065959"/>
            <a:ext cx="11260347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Supplementary figure.2 Calibration curves of the Cox prediction model at different follow-up time points.</a:t>
            </a:r>
          </a:p>
          <a:p>
            <a:r>
              <a:rPr lang="en-US" altLang="zh-CN" dirty="0"/>
              <a:t>(A) 1-year calibration; (B) 3-year calibration; (C) 5-year calibration.</a:t>
            </a:r>
          </a:p>
          <a:p>
            <a:r>
              <a:rPr lang="en-US" altLang="zh-CN" dirty="0"/>
              <a:t>The dashed line represents perfect calibration. The calibration plots demonstrate good agreement between predicted and observed risks, particularly at 5 years.</a:t>
            </a: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35EE8AF1-E86F-D87E-0196-80F5E0C26C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4838" y="-95796"/>
            <a:ext cx="6774884" cy="49422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77159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680192D9-7F8D-8850-94B3-314B179138FD}"/>
              </a:ext>
            </a:extLst>
          </p:cNvPr>
          <p:cNvSpPr txBox="1"/>
          <p:nvPr/>
        </p:nvSpPr>
        <p:spPr>
          <a:xfrm>
            <a:off x="586596" y="5712450"/>
            <a:ext cx="114846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Supplementary figure.3  Nomogram for predicting 1-, 3-, and 5-year risk of composite endpoint events</a:t>
            </a:r>
            <a:endParaRPr lang="zh-CN" altLang="en-US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6243A2D7-6AB4-CEE3-9645-D1416CEAB22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326" b="35658"/>
          <a:stretch>
            <a:fillRect/>
          </a:stretch>
        </p:blipFill>
        <p:spPr>
          <a:xfrm>
            <a:off x="472209" y="1065196"/>
            <a:ext cx="9896338" cy="45189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59808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109</Words>
  <Application>Microsoft Office PowerPoint</Application>
  <PresentationFormat>宽屏</PresentationFormat>
  <Paragraphs>8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7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阳 濮</dc:creator>
  <cp:lastModifiedBy>阳 濮</cp:lastModifiedBy>
  <cp:revision>1</cp:revision>
  <dcterms:created xsi:type="dcterms:W3CDTF">2025-07-14T16:28:03Z</dcterms:created>
  <dcterms:modified xsi:type="dcterms:W3CDTF">2025-12-13T08:27:37Z</dcterms:modified>
</cp:coreProperties>
</file>